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16F739-59B9-403A-B3C0-1ACD6643659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05DE8B-930A-4772-980B-D38084FD35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9CD339-8B13-46E7-A4BF-F6CC82D19FE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266376-B6F8-409A-A34A-401336DCF8E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676B30-9B73-45E8-84DB-F4BFB1394B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25A35B-9E2F-4F2B-853C-EDE2CED5A0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FDCF5A-B135-4895-8844-4AAD1DF42F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54D77-2CEC-4F90-8152-0CEB546B68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97476F-F211-4E8C-9AAF-7A09F6EDB6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7A96D3-0231-448F-BAAC-FED00D0D15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83CAC1-77F1-41FA-9027-6A109F366D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A6BC73-DFA1-454B-92C8-13191B33AC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굴림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굴림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1E9CDB8-D3CA-45E9-8B4C-DF781BFBBBEC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547640" y="692280"/>
          <a:ext cx="6120000" cy="47797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547640" y="692280"/>
                    <a:ext cx="6120000" cy="4779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5613480" y="1773360"/>
            <a:ext cx="18396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44" name="" descr=""/>
          <p:cNvPicPr/>
          <p:nvPr/>
        </p:nvPicPr>
        <p:blipFill>
          <a:blip r:embed="rId3"/>
          <a:stretch/>
        </p:blipFill>
        <p:spPr>
          <a:xfrm>
            <a:off x="5464080" y="1722600"/>
            <a:ext cx="1027080" cy="26352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4"/>
          <a:stretch/>
        </p:blipFill>
        <p:spPr>
          <a:xfrm>
            <a:off x="5464080" y="1501920"/>
            <a:ext cx="1024200" cy="22860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5"/>
          <a:stretch/>
        </p:blipFill>
        <p:spPr>
          <a:xfrm>
            <a:off x="5464080" y="1971720"/>
            <a:ext cx="1024200" cy="26496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6"/>
          <a:stretch/>
        </p:blipFill>
        <p:spPr>
          <a:xfrm>
            <a:off x="5464080" y="2222640"/>
            <a:ext cx="1024200" cy="27612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5464080" y="1501920"/>
            <a:ext cx="0" cy="1001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9" name=""/>
          <p:cNvSpPr/>
          <p:nvPr/>
        </p:nvSpPr>
        <p:spPr>
          <a:xfrm>
            <a:off x="6488280" y="1501920"/>
            <a:ext cx="0" cy="1001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0" name=""/>
          <p:cNvSpPr/>
          <p:nvPr/>
        </p:nvSpPr>
        <p:spPr>
          <a:xfrm>
            <a:off x="5464080" y="1501920"/>
            <a:ext cx="102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1" name=""/>
          <p:cNvSpPr/>
          <p:nvPr/>
        </p:nvSpPr>
        <p:spPr>
          <a:xfrm>
            <a:off x="5464080" y="2222640"/>
            <a:ext cx="102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2" name=""/>
          <p:cNvSpPr/>
          <p:nvPr/>
        </p:nvSpPr>
        <p:spPr>
          <a:xfrm>
            <a:off x="5464080" y="1722600"/>
            <a:ext cx="102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3" name=""/>
          <p:cNvSpPr/>
          <p:nvPr/>
        </p:nvSpPr>
        <p:spPr>
          <a:xfrm>
            <a:off x="5464080" y="1971720"/>
            <a:ext cx="102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4" name=""/>
          <p:cNvSpPr/>
          <p:nvPr/>
        </p:nvSpPr>
        <p:spPr>
          <a:xfrm>
            <a:off x="5464080" y="2503440"/>
            <a:ext cx="102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5" name=""/>
          <p:cNvSpPr/>
          <p:nvPr/>
        </p:nvSpPr>
        <p:spPr>
          <a:xfrm>
            <a:off x="5435640" y="1217520"/>
            <a:ext cx="1224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ko-KR" sz="900" spc="-1" strike="noStrike">
                <a:solidFill>
                  <a:srgbClr val="000000"/>
                </a:solidFill>
                <a:latin typeface="Times New Roman"/>
              </a:rPr>
              <a:t>MetA  I124L   I229Y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6" name=""/>
          <p:cNvSpPr/>
          <p:nvPr/>
        </p:nvSpPr>
        <p:spPr>
          <a:xfrm>
            <a:off x="6452640" y="1482840"/>
            <a:ext cx="839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30</a:t>
            </a: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</a:rPr>
              <a:t>0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C, Ins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7" name=""/>
          <p:cNvSpPr/>
          <p:nvPr/>
        </p:nvSpPr>
        <p:spPr>
          <a:xfrm>
            <a:off x="6485760" y="1730520"/>
            <a:ext cx="839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45</a:t>
            </a: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</a:rPr>
              <a:t>0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C, Ins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8" name=""/>
          <p:cNvSpPr/>
          <p:nvPr/>
        </p:nvSpPr>
        <p:spPr>
          <a:xfrm>
            <a:off x="6450120" y="1974960"/>
            <a:ext cx="1074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30</a:t>
            </a: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</a:rPr>
              <a:t>0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C, Sol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9" name=""/>
          <p:cNvSpPr/>
          <p:nvPr/>
        </p:nvSpPr>
        <p:spPr>
          <a:xfrm>
            <a:off x="6450480" y="2212920"/>
            <a:ext cx="858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45</a:t>
            </a: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</a:rPr>
              <a:t>0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C, Sol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0" name=""/>
          <p:cNvSpPr/>
          <p:nvPr/>
        </p:nvSpPr>
        <p:spPr>
          <a:xfrm>
            <a:off x="988200" y="5660640"/>
            <a:ext cx="6738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ko-KR" sz="1600" spc="-1" strike="noStrike">
                <a:solidFill>
                  <a:srgbClr val="000000"/>
                </a:solidFill>
                <a:latin typeface="Times New Roman"/>
              </a:rPr>
              <a:t>     </a:t>
            </a:r>
            <a:r>
              <a:rPr b="1" lang="ko-KR" sz="1600" spc="-1" strike="noStrike">
                <a:solidFill>
                  <a:srgbClr val="000000"/>
                </a:solidFill>
                <a:latin typeface="Times New Roman"/>
              </a:rPr>
              <a:t>Figure S3  Densitometric analysis of MetAs in the heat-stressed cultures.</a:t>
            </a:r>
            <a:r>
              <a:rPr b="0" lang="ko-KR" sz="16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19T04:45:30Z</dcterms:created>
  <dc:creator>user</dc:creator>
  <dc:description/>
  <dc:language>en-US</dc:language>
  <cp:lastModifiedBy>user</cp:lastModifiedBy>
  <dcterms:modified xsi:type="dcterms:W3CDTF">2013-06-05T08:29:59Z</dcterms:modified>
  <cp:revision>12</cp:revision>
  <dc:subject/>
  <dc:title>슬라이드 1</dc:title>
</cp:coreProperties>
</file>